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6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1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09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774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329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63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499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28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70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961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654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56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72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25CC7-60C2-4DA8-9CDD-99F9D6456A97}" type="datetimeFigureOut">
              <a:rPr lang="en-US" smtClean="0"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F3E35-4FEE-47BA-AAAA-6DFE6E6ACB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547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58641" y="516367"/>
            <a:ext cx="8401265" cy="3659178"/>
            <a:chOff x="194094" y="179271"/>
            <a:chExt cx="11360015" cy="507204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094" y="179271"/>
              <a:ext cx="11325832" cy="507204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 flipV="1">
              <a:off x="1216324" y="3920790"/>
              <a:ext cx="10303603" cy="124052"/>
            </a:xfrm>
            <a:prstGeom prst="rect">
              <a:avLst/>
            </a:prstGeom>
            <a:noFill/>
            <a:ln w="28575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 flipV="1">
              <a:off x="1066800" y="4295955"/>
              <a:ext cx="2935858" cy="108320"/>
            </a:xfrm>
            <a:prstGeom prst="rect">
              <a:avLst/>
            </a:prstGeom>
            <a:noFill/>
            <a:ln w="28575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 flipV="1">
              <a:off x="1032618" y="2227382"/>
              <a:ext cx="10521491" cy="112733"/>
            </a:xfrm>
            <a:prstGeom prst="rect">
              <a:avLst/>
            </a:prstGeom>
            <a:noFill/>
            <a:ln w="28575" cap="flat" cmpd="sng" algn="ctr">
              <a:solidFill>
                <a:srgbClr val="00206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 flipV="1">
              <a:off x="10625961" y="1860331"/>
              <a:ext cx="928148" cy="115939"/>
            </a:xfrm>
            <a:prstGeom prst="rect">
              <a:avLst/>
            </a:prstGeom>
            <a:noFill/>
            <a:ln w="28575" cap="flat" cmpd="sng" algn="ctr">
              <a:solidFill>
                <a:srgbClr val="00206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 flipV="1">
              <a:off x="1032618" y="2577026"/>
              <a:ext cx="10487308" cy="112732"/>
            </a:xfrm>
            <a:prstGeom prst="rect">
              <a:avLst/>
            </a:prstGeom>
            <a:noFill/>
            <a:ln w="28575" cap="flat" cmpd="sng" algn="ctr">
              <a:solidFill>
                <a:srgbClr val="00206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 flipV="1">
              <a:off x="1032618" y="2940870"/>
              <a:ext cx="7827603" cy="132882"/>
            </a:xfrm>
            <a:prstGeom prst="rect">
              <a:avLst/>
            </a:prstGeom>
            <a:noFill/>
            <a:ln w="28575" cap="flat" cmpd="sng" algn="ctr">
              <a:solidFill>
                <a:srgbClr val="00206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12" name="Rectangle 11"/>
          <p:cNvSpPr/>
          <p:nvPr/>
        </p:nvSpPr>
        <p:spPr>
          <a:xfrm>
            <a:off x="421712" y="4569469"/>
            <a:ext cx="839061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ignment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i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XTH</a:t>
            </a:r>
            <a:r>
              <a:rPr lang="en-US" sz="120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like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selected for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formation and location of unique sequences for silencing individual family members. Diagram of 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200" i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TH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amily member sequences and position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quence fragments used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silence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vidual  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200" i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TH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switchgrass.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iqu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XTH-like1b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silencing </a:t>
            </a:r>
            <a:r>
              <a:rPr lang="en-US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TH-1b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s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ted in the  red box and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ique </a:t>
            </a:r>
            <a:r>
              <a:rPr lang="en-US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XTH-like2a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quence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silencing</a:t>
            </a:r>
            <a:r>
              <a:rPr lang="en-US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XTH-2a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is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ted in blue box. Areas with identity between the sequences are highlighted.</a:t>
            </a:r>
          </a:p>
        </p:txBody>
      </p:sp>
    </p:spTree>
    <p:extLst>
      <p:ext uri="{BB962C8B-B14F-4D97-AF65-F5344CB8AC3E}">
        <p14:creationId xmlns:p14="http://schemas.microsoft.com/office/powerpoint/2010/main" val="899910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7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lson, Rick</dc:creator>
  <cp:lastModifiedBy>Nelson, Rick</cp:lastModifiedBy>
  <cp:revision>5</cp:revision>
  <dcterms:created xsi:type="dcterms:W3CDTF">2017-08-04T20:43:09Z</dcterms:created>
  <dcterms:modified xsi:type="dcterms:W3CDTF">2017-12-16T20:22:16Z</dcterms:modified>
</cp:coreProperties>
</file>